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60" r:id="rId1"/>
  </p:sldMasterIdLst>
  <p:sldIdLst>
    <p:sldId id="256" r:id="rId2"/>
  </p:sldIdLst>
  <p:sldSz cx="12192000" cy="6858000"/>
  <p:notesSz cx="6858000" cy="9144000"/>
  <p:defaultTextStyle>
    <a:defPPr>
      <a:defRPr lang="it-G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196"/>
  </p:normalViewPr>
  <p:slideViewPr>
    <p:cSldViewPr snapToGrid="0">
      <p:cViewPr varScale="1">
        <p:scale>
          <a:sx n="76" d="100"/>
          <a:sy n="76" d="100"/>
        </p:scale>
        <p:origin x="216" y="6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79B0247-3028-66FD-48A9-31C753B960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FCECA230-6694-6D02-FE84-08619D67B7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C52A363-AA06-6233-7A24-86D4155C09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A824-1A51-4B26-AD58-A6D8E14F6C04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A7898B0-60B8-E78C-FB8D-E58ECF5D0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4CBB9C3-0C69-7FF6-1C02-7BDED3042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8944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45353AF-CEF0-AE61-F15F-D4AB1EAAF3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4188791-1F15-B774-6BB6-43CF9A2BE4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8AE8B87-8489-72BE-97F3-2A3CA2CA5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7E33E-8B18-4087-B112-809917729534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9D09452-4F8C-ED1D-CF1F-E6DA408AE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6832EE5-1677-F306-4F1A-4A9A2C661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0269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291616E-5D5F-674A-7AD2-D78178B9E8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2AB0148-0415-2111-FE62-05011C18A7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BED1970-D23B-F069-1BD7-5E75F9CEC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B772B75-1BED-920E-3694-B6818B8F9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94F4824-342F-34D8-3ECA-A0DD562999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0080843"/>
      </p:ext>
    </p:extLst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C2A9524-54DD-D19D-FFE2-864A5596D2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C760B5B-A8BD-64B6-B16E-F49F4FE4E9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F21685C-66A3-0FA5-FBFE-DC7D242AE4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162C4-EDD9-4389-A98B-B87ECEA2A816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F9FA258-4A91-BAB7-9578-D7E684CC5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A1561A1-7595-8107-267D-EDAEB6B68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3562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6713505-6366-2B7D-AFA9-4DC13D0B8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8041EEF-B5C6-BF9D-1A69-103E007FE6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3C1FF95-A197-0499-793F-855C5FE04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059C3-6A89-4494-99FF-5A4D6FFD50EB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7FA99F9-1FEC-E9AA-5418-ED5B4A44C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B3AF556-C7B6-7FB7-3155-11E315B5F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4068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3AB5ABE-8E52-1B13-3218-CECF01160D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4898695-A2E6-165D-A775-B834A3FE41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C170675-7758-F751-02D9-123FB27DCD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607CF14-7E02-0471-0DA7-86716CD62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4B2F-12DE-47F5-8894-472B206D2E1E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FA1D3D7-80B1-515B-14C6-87C88EA41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55676AB-4B2C-14A8-D920-476451213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9720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5C01E7E-96D9-8580-A424-B313D070C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CF15502-3C4A-D90E-1E82-E66D4BFD9A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BA1EA66-B8A7-0381-44A2-09B7BB0A3B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C27C7861-8B15-361C-F0FF-C9FCF44B7F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4BD952B-1264-DD40-4DDA-15AC89A438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CE789FB-ED9A-A60A-8010-B02899217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0E46F-7819-4ACF-B48B-48222C2ACC88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F6251CC-8638-1F0D-30BF-B304C52EA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7004A1E-C338-2741-0656-6E34CFD3A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4388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A93204-6419-1432-65D8-85A3B52332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9967155-EFB2-14EB-1F44-850DD787A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F3416-4057-4DAA-829D-4CA07428D088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A05AEF6-0EC6-4C3E-6A86-C8D30C2EBF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5448170-B0AD-4E10-A13A-B9A75B22C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2608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90342350-C311-6423-2E60-2D66096E6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D9284-D300-4297-87F7-E791DCC15DB1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01DAE9D-6EEC-A62C-4940-9D6FCD19D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AB73F55-E40A-BCA4-7E3F-BAD77FCC03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3017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9482ED6-3C4A-1824-1DF6-48FE91FB39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22E0BC0-FC47-B90C-4D08-FA418C2D7F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1E0E662-1462-ACC2-2B8B-C77AF1E60F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3F4BA8C-F416-B741-10F8-CA2BA2B35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25BB-DA17-4BA0-B3C8-3AC3ABC827E6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E98A24E-1A93-3795-8AE3-06FE724A7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4D516B5-6B65-D8B8-D4E7-39CC7D969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74197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A9C06E-603F-D4F4-CED8-4318C5BB0A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4EDAFE1-3A50-664B-B5DD-A860415580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B3FACB1-8056-A6B3-0CFB-D7C5289BAE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4D53B09-22D5-EA60-BD67-9316BAB77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C4C9A-3960-41CF-A4E9-2A8FB932454B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6A1D6D8-502C-CC65-ED72-763636AF2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2BBAD87-F727-61F3-1994-923257989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7506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52B8AB3-F313-BAEC-51F5-9000FD770A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62826FC-B583-26C9-A1F2-02F6CA62BA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A740461-4366-2874-76B7-823B82E79E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C1C18-307B-4F68-A007-B5B542270E8D}" type="datetimeFigureOut">
              <a:rPr lang="en-US" smtClean="0"/>
              <a:t>12/2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2C8FFC5-0CCC-FC0C-562A-BAB3734002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059377A-3FEF-3BEB-F25B-1C4AC3E92A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4170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G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0F2247C1-BFA2-017B-29DB-6FABF712D528}"/>
              </a:ext>
            </a:extLst>
          </p:cNvPr>
          <p:cNvSpPr txBox="1"/>
          <p:nvPr/>
        </p:nvSpPr>
        <p:spPr>
          <a:xfrm>
            <a:off x="7111741" y="174869"/>
            <a:ext cx="4175383" cy="1021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oomassie-stained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gel </a:t>
            </a:r>
          </a:p>
          <a:p>
            <a:pPr>
              <a:lnSpc>
                <a:spcPct val="150000"/>
              </a:lnSpc>
            </a:pP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GST-pull down of 6xHis</a:t>
            </a:r>
            <a:r>
              <a:rPr lang="it-IT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epB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by GST-FANCJ-CIP box WT and AALA </a:t>
            </a:r>
          </a:p>
        </p:txBody>
      </p:sp>
      <p:pic>
        <p:nvPicPr>
          <p:cNvPr id="5" name="Immagine 4" descr="Immagine che contiene bianco e nero, schizzo, bianco, muro&#10;&#10;Descrizione generata automaticamente">
            <a:extLst>
              <a:ext uri="{FF2B5EF4-FFF2-40B4-BE49-F238E27FC236}">
                <a16:creationId xmlns:a16="http://schemas.microsoft.com/office/drawing/2014/main" id="{9377743A-99ED-2C13-B881-2A8AD46FEBF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455" r="45931"/>
          <a:stretch/>
        </p:blipFill>
        <p:spPr>
          <a:xfrm>
            <a:off x="1719263" y="174870"/>
            <a:ext cx="4648200" cy="6508261"/>
          </a:xfrm>
          <a:prstGeom prst="rect">
            <a:avLst/>
          </a:prstGeom>
        </p:spPr>
      </p:pic>
      <p:grpSp>
        <p:nvGrpSpPr>
          <p:cNvPr id="6" name="Gruppo 5">
            <a:extLst>
              <a:ext uri="{FF2B5EF4-FFF2-40B4-BE49-F238E27FC236}">
                <a16:creationId xmlns:a16="http://schemas.microsoft.com/office/drawing/2014/main" id="{1C81B5DA-E6CC-A37D-9383-D9880B65BE63}"/>
              </a:ext>
            </a:extLst>
          </p:cNvPr>
          <p:cNvGrpSpPr/>
          <p:nvPr/>
        </p:nvGrpSpPr>
        <p:grpSpPr>
          <a:xfrm>
            <a:off x="2858514" y="1597126"/>
            <a:ext cx="865141" cy="2129924"/>
            <a:chOff x="2815651" y="1597125"/>
            <a:chExt cx="865141" cy="2129924"/>
          </a:xfrm>
        </p:grpSpPr>
        <p:grpSp>
          <p:nvGrpSpPr>
            <p:cNvPr id="12" name="Gruppo 11">
              <a:extLst>
                <a:ext uri="{FF2B5EF4-FFF2-40B4-BE49-F238E27FC236}">
                  <a16:creationId xmlns:a16="http://schemas.microsoft.com/office/drawing/2014/main" id="{D5531D3D-7FB6-7A4D-1ECA-BAC7C155F24D}"/>
                </a:ext>
              </a:extLst>
            </p:cNvPr>
            <p:cNvGrpSpPr/>
            <p:nvPr/>
          </p:nvGrpSpPr>
          <p:grpSpPr>
            <a:xfrm>
              <a:off x="2818427" y="1819148"/>
              <a:ext cx="862365" cy="1907901"/>
              <a:chOff x="5932688" y="2707043"/>
              <a:chExt cx="862365" cy="1907901"/>
            </a:xfrm>
          </p:grpSpPr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CFDFE03C-4206-CB92-5E14-B91E8D99CC0B}"/>
                  </a:ext>
                </a:extLst>
              </p:cNvPr>
              <p:cNvSpPr txBox="1"/>
              <p:nvPr/>
            </p:nvSpPr>
            <p:spPr>
              <a:xfrm>
                <a:off x="5932688" y="2707043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96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36BFE37F-58F0-5332-B1C2-7E41EF6D94F9}"/>
                  </a:ext>
                </a:extLst>
              </p:cNvPr>
              <p:cNvSpPr txBox="1"/>
              <p:nvPr/>
            </p:nvSpPr>
            <p:spPr>
              <a:xfrm>
                <a:off x="5935804" y="2998064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64</a:t>
                </a:r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82392334-49F6-5EFA-C661-F6A9B9884540}"/>
                  </a:ext>
                </a:extLst>
              </p:cNvPr>
              <p:cNvSpPr txBox="1"/>
              <p:nvPr/>
            </p:nvSpPr>
            <p:spPr>
              <a:xfrm>
                <a:off x="5946847" y="3558585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5</a:t>
                </a: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F5926CCD-FEEC-05B1-ACCB-8B405639447D}"/>
                  </a:ext>
                </a:extLst>
              </p:cNvPr>
              <p:cNvSpPr txBox="1"/>
              <p:nvPr/>
            </p:nvSpPr>
            <p:spPr>
              <a:xfrm>
                <a:off x="5963780" y="4337945"/>
                <a:ext cx="8312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1</a:t>
                </a:r>
              </a:p>
            </p:txBody>
          </p:sp>
        </p:grp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98107EA9-FFC9-4B48-B0C7-07780E3AD197}"/>
                </a:ext>
              </a:extLst>
            </p:cNvPr>
            <p:cNvSpPr txBox="1"/>
            <p:nvPr/>
          </p:nvSpPr>
          <p:spPr>
            <a:xfrm>
              <a:off x="2815651" y="1597125"/>
              <a:ext cx="8312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116</a:t>
              </a:r>
            </a:p>
          </p:txBody>
        </p:sp>
      </p:grpSp>
      <p:sp>
        <p:nvSpPr>
          <p:cNvPr id="7" name="Rettangolo 6">
            <a:extLst>
              <a:ext uri="{FF2B5EF4-FFF2-40B4-BE49-F238E27FC236}">
                <a16:creationId xmlns:a16="http://schemas.microsoft.com/office/drawing/2014/main" id="{D64855CD-057C-2DBB-C576-37110360C42F}"/>
              </a:ext>
            </a:extLst>
          </p:cNvPr>
          <p:cNvSpPr/>
          <p:nvPr/>
        </p:nvSpPr>
        <p:spPr>
          <a:xfrm>
            <a:off x="5025680" y="2070414"/>
            <a:ext cx="980661" cy="3693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ttangolo 7">
            <a:extLst>
              <a:ext uri="{FF2B5EF4-FFF2-40B4-BE49-F238E27FC236}">
                <a16:creationId xmlns:a16="http://schemas.microsoft.com/office/drawing/2014/main" id="{D16A6A16-9B6A-55D9-CA83-3FD26BB647EF}"/>
              </a:ext>
            </a:extLst>
          </p:cNvPr>
          <p:cNvSpPr/>
          <p:nvPr/>
        </p:nvSpPr>
        <p:spPr>
          <a:xfrm>
            <a:off x="3780649" y="3429000"/>
            <a:ext cx="2079918" cy="49364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BED0BFBD-8CB7-6830-B0DA-70612EAEA793}"/>
              </a:ext>
            </a:extLst>
          </p:cNvPr>
          <p:cNvSpPr txBox="1"/>
          <p:nvPr/>
        </p:nvSpPr>
        <p:spPr>
          <a:xfrm rot="16200000">
            <a:off x="3706589" y="4995479"/>
            <a:ext cx="979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602567BC-EC5B-849C-1D13-C0A43F17E587}"/>
              </a:ext>
            </a:extLst>
          </p:cNvPr>
          <p:cNvSpPr txBox="1"/>
          <p:nvPr/>
        </p:nvSpPr>
        <p:spPr>
          <a:xfrm rot="16200000">
            <a:off x="4610660" y="4630698"/>
            <a:ext cx="1709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GST-CIP box WT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264B5E3-6889-BB42-FF01-EEC127339EFE}"/>
              </a:ext>
            </a:extLst>
          </p:cNvPr>
          <p:cNvSpPr txBox="1"/>
          <p:nvPr/>
        </p:nvSpPr>
        <p:spPr>
          <a:xfrm rot="16200000">
            <a:off x="3811697" y="4476810"/>
            <a:ext cx="20168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GST-CIP box AALA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936EEE1D-BEEB-56C5-2178-A063282B9022}"/>
              </a:ext>
            </a:extLst>
          </p:cNvPr>
          <p:cNvSpPr txBox="1"/>
          <p:nvPr/>
        </p:nvSpPr>
        <p:spPr>
          <a:xfrm>
            <a:off x="6321321" y="2108828"/>
            <a:ext cx="1015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6xHis</a:t>
            </a:r>
            <a:r>
              <a:rPr lang="en-GB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pB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1653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Words>27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A MARIA PISANI</dc:creator>
  <cp:lastModifiedBy>FRANCESCA MARIA PISANI</cp:lastModifiedBy>
  <cp:revision>3</cp:revision>
  <dcterms:created xsi:type="dcterms:W3CDTF">2023-11-30T11:12:14Z</dcterms:created>
  <dcterms:modified xsi:type="dcterms:W3CDTF">2023-12-02T15:46:22Z</dcterms:modified>
</cp:coreProperties>
</file>